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48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FC660A-6362-472D-9D87-AFD51C8C4032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9FD08F-3E1A-44AC-B073-640877D526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60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014303-1DE8-F545-996F-8D127D53078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6394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2FAF6-FEB3-B00F-07D1-D0F8CF1C00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F248FA-F7B4-3E0A-38C2-D7CE464318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FE8349-F59D-8A98-1CD8-183019D49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CC227-4DA5-E5ED-1CF7-D87D98BA0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4EC5F-667E-77FD-54B7-06E24256C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542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D673E-B6E8-83AA-0810-3E11380EA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F01A2B-A08E-57A2-8B05-0B1854D0E9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088677-7F28-AA3C-48C1-EE9B7123F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E0BC4-D94D-0456-6CEE-92C57DEED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21382-4DB0-94C6-1C47-1F46B8EC7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724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C974B1-19F5-1B6A-A59C-AF31C543FD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8BA35A-CFE2-C83A-5BA7-6D351B8D90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B6150-998B-C360-361F-AD5ABF1A8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1AE4DB-C567-D59D-D1C4-0DE9B89E1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A4E3E8-861B-5E55-A6C9-C6E58339D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72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64576-302A-D91A-DEF1-972C579A5E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CE998C-FB2D-8774-7D26-FFE79613F3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F0EF65-3C6D-2CF2-30E1-B3FAB8AF9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8B3D4B-8457-8F50-4548-52A47C634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D488CF-0997-CA6E-6EAC-7C9FAD5BC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64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BE84C-C234-3B2A-F9DA-776BA96F2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0BC16F-8121-A28E-865B-82C1B2F20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86D4A-8631-A8E3-9CED-2C6791CF5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097115-AA4A-FD8D-FCFE-56E8B31BC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9C4D08-B57B-8AED-1F27-8BF2AFDCF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389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69065-9DBB-42EC-7EB5-15251DBF1D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2811BC-DBEA-6E83-BF75-1852CE9DEE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6AD37D-90D1-23ED-3BE4-B5E63DF29E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F6D14A-CC53-0FB9-3A35-CF61301FA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8B13BD-C37D-D4CA-A19A-555B20380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B29464-0DDD-845F-29DD-0B720C349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333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C035B-0085-0A8C-97BF-B91D0EC49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BED1D3-54BD-2A19-AECE-1B41055674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165B22-CA44-66BF-88CE-788337EB3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970B41B-D475-6D19-3C4A-8ADF0EBAE2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B3AEA2-9EFE-1D92-25EC-3F9F1A5BB3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9EC93E-2631-A50E-343F-D2589B293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8EBF25-36D5-9D80-FA61-3EEAE8487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14AB9-2FA9-374B-6196-6FB859C14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902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4CEAF-3FFE-CCDA-9647-00CB093DC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CDAED73-AE0B-A5AB-C27D-D561D274A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497E0A-790A-C1D5-7016-7BA49BC59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73E012-EC40-A3FC-BBE6-3BA6F4F9D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981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073AE5-CA01-8399-C9ED-C4A38AF2E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C67658-1C31-4054-24A0-EDF2632B4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0F45A1-1ED0-EFE4-C76D-EBA6529A7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332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8F2E6-8FE4-4795-8635-279B8DBA3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A1ED02-AD4A-D4C1-847C-A50DFFAFBF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E78B3C-0933-EE30-F062-CA2EC0A703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CAA735-C13D-C8AF-DD5F-3201D7717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1B2728-7E22-074A-7ABA-D9F7AE5E1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4CDBA0-16B2-680F-B7FE-BF20E28C2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723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CD0B9-BC65-5FCA-053E-9D7B62FA9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B9B797-92E6-7BE8-2CD2-AF1482480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86EE3F-B4B7-6587-475F-3E12B64411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CB9B88-13C9-BBB7-E5D5-B4761BF3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535B70-200A-5707-B6A1-AD34C5568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65569C-5CB4-94F2-5EDA-B80B01CBE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216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3DB0B8-C693-837F-F761-9CD4235D7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211DD7-90FF-D32F-48AA-F3163EF5CF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0A97AB-FC29-A90D-303F-9A60B37E1E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D3094-87E7-40B8-AACF-5AFADE3CB58E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3952CC-7842-74A8-94A2-C16A1F3EA1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3885B-DF53-2DB3-7CE2-BB0927CE94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B2BDC-4ECA-4A93-8263-AEC3FFBA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400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TextBox 209">
            <a:extLst>
              <a:ext uri="{FF2B5EF4-FFF2-40B4-BE49-F238E27FC236}">
                <a16:creationId xmlns:a16="http://schemas.microsoft.com/office/drawing/2014/main" id="{B3134A85-36EB-0DE7-5395-D581123CACE8}"/>
              </a:ext>
            </a:extLst>
          </p:cNvPr>
          <p:cNvSpPr txBox="1"/>
          <p:nvPr/>
        </p:nvSpPr>
        <p:spPr>
          <a:xfrm>
            <a:off x="2207551" y="4385301"/>
            <a:ext cx="7011482" cy="16068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84" b="1" dirty="0">
                <a:latin typeface="Palatino Linotype" panose="02040502050505030304" pitchFamily="18" charset="0"/>
              </a:rPr>
              <a:t>Supplementary Figure S1.</a:t>
            </a:r>
            <a:r>
              <a:rPr lang="en-US" sz="984" dirty="0">
                <a:latin typeface="Palatino Linotype" panose="02040502050505030304" pitchFamily="18" charset="0"/>
              </a:rPr>
              <a:t> </a:t>
            </a:r>
            <a:r>
              <a:rPr lang="en-US" sz="984" b="1" dirty="0">
                <a:latin typeface="Palatino Linotype" panose="02040502050505030304" pitchFamily="18" charset="0"/>
              </a:rPr>
              <a:t>Schematic of the Experimental design </a:t>
            </a:r>
            <a:r>
              <a:rPr lang="en-US" sz="984" dirty="0">
                <a:latin typeface="Palatino Linotype" panose="02040502050505030304" pitchFamily="18" charset="0"/>
              </a:rPr>
              <a:t>(see </a:t>
            </a:r>
            <a:r>
              <a:rPr lang="en-US" sz="984" i="1" dirty="0">
                <a:latin typeface="Palatino Linotype" panose="02040502050505030304" pitchFamily="18" charset="0"/>
              </a:rPr>
              <a:t>Materials and Methods </a:t>
            </a:r>
            <a:r>
              <a:rPr lang="en-US" sz="984" dirty="0">
                <a:latin typeface="Palatino Linotype" panose="02040502050505030304" pitchFamily="18" charset="0"/>
              </a:rPr>
              <a:t>for details). Male and female wild-type and </a:t>
            </a:r>
            <a:r>
              <a:rPr lang="en-US" sz="984" dirty="0" err="1">
                <a:latin typeface="Palatino Linotype" panose="02040502050505030304" pitchFamily="18" charset="0"/>
              </a:rPr>
              <a:t>trigenic</a:t>
            </a:r>
            <a:r>
              <a:rPr lang="en-US" sz="984" dirty="0">
                <a:latin typeface="Palatino Linotype" panose="02040502050505030304" pitchFamily="18" charset="0"/>
              </a:rPr>
              <a:t> APP/BIN1/COPS5 AD mice (3–4- and 8–9-months-old) were injected intraperitoneally with vehicle (0.9% NaCl, saline), or </a:t>
            </a:r>
            <a:r>
              <a:rPr lang="en-US" sz="984" dirty="0" err="1">
                <a:latin typeface="Palatino Linotype" panose="02040502050505030304" pitchFamily="18" charset="0"/>
              </a:rPr>
              <a:t>Nosustrophine</a:t>
            </a:r>
            <a:r>
              <a:rPr lang="en-US" sz="984" dirty="0">
                <a:latin typeface="Palatino Linotype" panose="02040502050505030304" pitchFamily="18" charset="0"/>
              </a:rPr>
              <a:t> (100 mg/kg) once daily for four weeks. Hippocampi were removed and AD-related, inflammation-associated gene expression, global and de novo DNA methylation, HDAC3 expression and HDAC activity, and SIRT1 expression measured. Brain sections were also </a:t>
            </a:r>
            <a:r>
              <a:rPr lang="en-US" sz="984" dirty="0" err="1">
                <a:latin typeface="Palatino Linotype" panose="02040502050505030304" pitchFamily="18" charset="0"/>
              </a:rPr>
              <a:t>immunostained</a:t>
            </a:r>
            <a:r>
              <a:rPr lang="en-US" sz="984" dirty="0">
                <a:latin typeface="Palatino Linotype" panose="02040502050505030304" pitchFamily="18" charset="0"/>
              </a:rPr>
              <a:t> for </a:t>
            </a:r>
            <a:r>
              <a:rPr lang="en-US" sz="984" dirty="0" err="1">
                <a:latin typeface="Palatino Linotype" panose="02040502050505030304" pitchFamily="18" charset="0"/>
              </a:rPr>
              <a:t>NeuN</a:t>
            </a:r>
            <a:r>
              <a:rPr lang="en-US" sz="984" dirty="0">
                <a:latin typeface="Palatino Linotype" panose="02040502050505030304" pitchFamily="18" charset="0"/>
              </a:rPr>
              <a:t> and TH in these mice. 5mC, 5-methylcytosine; </a:t>
            </a:r>
            <a:r>
              <a:rPr lang="en-US" sz="984" i="1" dirty="0">
                <a:latin typeface="Palatino Linotype" panose="02040502050505030304" pitchFamily="18" charset="0"/>
              </a:rPr>
              <a:t>APOE, apolipoprotein E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APP/BIN1/COPS5 3xTg-AD, triple-transgenic mouse model of Alzheimer’s disease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it-IT" sz="984" i="1" dirty="0">
                <a:latin typeface="Palatino Linotype" panose="02040502050505030304" pitchFamily="18" charset="0"/>
              </a:rPr>
              <a:t>ABCB7, ATP binding cassette subfamily B member 7</a:t>
            </a:r>
            <a:r>
              <a:rPr lang="it-IT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DNMT, DNA methyltransferase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COX-2, cyclooxygenase-2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DNA methyltransferase 3a, DNMT3a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HDAC, histone deacetylase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it-IT" sz="984" dirty="0">
                <a:latin typeface="Palatino Linotype" panose="02040502050505030304" pitchFamily="18" charset="0"/>
              </a:rPr>
              <a:t>IL (interleukin)-1β, IL-6; </a:t>
            </a:r>
            <a:r>
              <a:rPr lang="it-IT" sz="984" i="1" dirty="0">
                <a:latin typeface="Palatino Linotype" panose="02040502050505030304" pitchFamily="18" charset="0"/>
              </a:rPr>
              <a:t>MAPT, microtubule-associated protein tau</a:t>
            </a:r>
            <a:r>
              <a:rPr lang="it-IT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 err="1">
                <a:latin typeface="Palatino Linotype" panose="02040502050505030304" pitchFamily="18" charset="0"/>
              </a:rPr>
              <a:t>NeuN</a:t>
            </a:r>
            <a:r>
              <a:rPr lang="en-US" sz="984" i="1" dirty="0">
                <a:latin typeface="Palatino Linotype" panose="02040502050505030304" pitchFamily="18" charset="0"/>
              </a:rPr>
              <a:t>, neuronal nuclear protein; NOS3, nitric oxide synthase 3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PSEN1, presenilin 1; PSEN2, presenilin 2</a:t>
            </a:r>
            <a:r>
              <a:rPr lang="en-US" sz="984" dirty="0">
                <a:latin typeface="Palatino Linotype" panose="02040502050505030304" pitchFamily="18" charset="0"/>
              </a:rPr>
              <a:t>; </a:t>
            </a:r>
            <a:r>
              <a:rPr lang="en-US" sz="984" i="1" dirty="0">
                <a:latin typeface="Palatino Linotype" panose="02040502050505030304" pitchFamily="18" charset="0"/>
              </a:rPr>
              <a:t>SIRT1, </a:t>
            </a:r>
            <a:r>
              <a:rPr lang="en-US" sz="984" i="1" dirty="0" err="1">
                <a:latin typeface="Palatino Linotype" panose="02040502050505030304" pitchFamily="18" charset="0"/>
              </a:rPr>
              <a:t>Sirtuin</a:t>
            </a:r>
            <a:r>
              <a:rPr lang="en-US" sz="984" i="1" dirty="0">
                <a:latin typeface="Palatino Linotype" panose="02040502050505030304" pitchFamily="18" charset="0"/>
              </a:rPr>
              <a:t>; TH, tyrosine hydroxylase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D32E2D81-B5CA-5F14-60B4-B9E2FF2CBF90}"/>
              </a:ext>
            </a:extLst>
          </p:cNvPr>
          <p:cNvGrpSpPr/>
          <p:nvPr/>
        </p:nvGrpSpPr>
        <p:grpSpPr>
          <a:xfrm>
            <a:off x="1964599" y="727197"/>
            <a:ext cx="7202177" cy="3440113"/>
            <a:chOff x="1964599" y="727197"/>
            <a:chExt cx="7202177" cy="344011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5BBF8BF-2F7D-4766-0527-7374261E1F03}"/>
                </a:ext>
              </a:extLst>
            </p:cNvPr>
            <p:cNvSpPr txBox="1"/>
            <p:nvPr/>
          </p:nvSpPr>
          <p:spPr>
            <a:xfrm>
              <a:off x="3789955" y="1068248"/>
              <a:ext cx="1218326" cy="272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1" dirty="0"/>
                <a:t>Wild-typ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0743FE0-51DD-48F6-F525-6C1BC895D723}"/>
                </a:ext>
              </a:extLst>
            </p:cNvPr>
            <p:cNvSpPr txBox="1"/>
            <p:nvPr/>
          </p:nvSpPr>
          <p:spPr>
            <a:xfrm>
              <a:off x="3771213" y="2264484"/>
              <a:ext cx="1237068" cy="4542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81" dirty="0"/>
                <a:t>APP/BIN1/COPS5</a:t>
              </a:r>
            </a:p>
            <a:p>
              <a:pPr algn="ctr"/>
              <a:r>
                <a:rPr lang="en-US" sz="1181" dirty="0"/>
                <a:t>3xTg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6A77B97-1066-EF58-FB41-56F414646D86}"/>
                </a:ext>
              </a:extLst>
            </p:cNvPr>
            <p:cNvSpPr txBox="1"/>
            <p:nvPr/>
          </p:nvSpPr>
          <p:spPr>
            <a:xfrm>
              <a:off x="3772484" y="1418382"/>
              <a:ext cx="1235798" cy="4542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1" dirty="0"/>
                <a:t>APP/BIN1/COPS5</a:t>
              </a:r>
            </a:p>
            <a:p>
              <a:pPr algn="ctr"/>
              <a:r>
                <a:rPr lang="en-US" sz="1181" dirty="0"/>
                <a:t>3xTg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51D1BEF-0F1A-A48B-C470-381A2039FB19}"/>
                </a:ext>
              </a:extLst>
            </p:cNvPr>
            <p:cNvSpPr txBox="1"/>
            <p:nvPr/>
          </p:nvSpPr>
          <p:spPr>
            <a:xfrm>
              <a:off x="3784791" y="1925998"/>
              <a:ext cx="1223490" cy="272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1" dirty="0"/>
                <a:t>Wild-type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21572E6-50AC-7657-03BF-6C7B3091BEE7}"/>
                </a:ext>
              </a:extLst>
            </p:cNvPr>
            <p:cNvSpPr txBox="1"/>
            <p:nvPr/>
          </p:nvSpPr>
          <p:spPr>
            <a:xfrm>
              <a:off x="2071174" y="1434674"/>
              <a:ext cx="1125605" cy="4542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81" dirty="0"/>
                <a:t>Complete randomizatio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FB5E587-1F87-2D66-EE50-D2C7E99ABF0C}"/>
                </a:ext>
              </a:extLst>
            </p:cNvPr>
            <p:cNvSpPr txBox="1"/>
            <p:nvPr/>
          </p:nvSpPr>
          <p:spPr>
            <a:xfrm>
              <a:off x="4935426" y="3470004"/>
              <a:ext cx="394660" cy="2740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81" dirty="0"/>
                <a:t>Sex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C646E83-AAFA-72CC-CECC-5903ECF63815}"/>
                </a:ext>
              </a:extLst>
            </p:cNvPr>
            <p:cNvSpPr txBox="1"/>
            <p:nvPr/>
          </p:nvSpPr>
          <p:spPr>
            <a:xfrm>
              <a:off x="4619848" y="3894747"/>
              <a:ext cx="502331" cy="272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81" dirty="0"/>
                <a:t>Mal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CFA4E43-614B-890A-985B-3C239CCC2E55}"/>
                </a:ext>
              </a:extLst>
            </p:cNvPr>
            <p:cNvSpPr txBox="1"/>
            <p:nvPr/>
          </p:nvSpPr>
          <p:spPr>
            <a:xfrm>
              <a:off x="5210814" y="3894747"/>
              <a:ext cx="629172" cy="272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81" dirty="0"/>
                <a:t>Female</a:t>
              </a:r>
            </a:p>
          </p:txBody>
        </p: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1C03A95A-FA00-19CF-7989-1AA8461F09E9}"/>
                </a:ext>
              </a:extLst>
            </p:cNvPr>
            <p:cNvCxnSpPr>
              <a:cxnSpLocks/>
              <a:endCxn id="10" idx="1"/>
            </p:cNvCxnSpPr>
            <p:nvPr/>
          </p:nvCxnSpPr>
          <p:spPr>
            <a:xfrm flipV="1">
              <a:off x="3196779" y="1204530"/>
              <a:ext cx="593176" cy="237078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63219F5B-888D-2480-92E2-A920D635D306}"/>
                </a:ext>
              </a:extLst>
            </p:cNvPr>
            <p:cNvCxnSpPr>
              <a:cxnSpLocks/>
              <a:endCxn id="11" idx="1"/>
            </p:cNvCxnSpPr>
            <p:nvPr/>
          </p:nvCxnSpPr>
          <p:spPr>
            <a:xfrm>
              <a:off x="3201855" y="1882747"/>
              <a:ext cx="569357" cy="60887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72A02E7-38B1-7B73-F7DC-E78702B8E8F0}"/>
                </a:ext>
              </a:extLst>
            </p:cNvPr>
            <p:cNvSpPr txBox="1"/>
            <p:nvPr/>
          </p:nvSpPr>
          <p:spPr>
            <a:xfrm>
              <a:off x="5339530" y="1321908"/>
              <a:ext cx="1104105" cy="45576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1" dirty="0"/>
                <a:t>Vehicle (saline)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D62A9DA-1FAA-3C5B-D082-9F1077D310A8}"/>
                </a:ext>
              </a:extLst>
            </p:cNvPr>
            <p:cNvSpPr txBox="1"/>
            <p:nvPr/>
          </p:nvSpPr>
          <p:spPr>
            <a:xfrm>
              <a:off x="5330411" y="2085933"/>
              <a:ext cx="1104105" cy="272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1" dirty="0" err="1"/>
                <a:t>Nosustrophine</a:t>
              </a:r>
              <a:endParaRPr lang="en-US" sz="1181" dirty="0"/>
            </a:p>
          </p:txBody>
        </p: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5FCE4803-59B9-A5D6-BB4D-BE12949B14F3}"/>
                </a:ext>
              </a:extLst>
            </p:cNvPr>
            <p:cNvCxnSpPr>
              <a:cxnSpLocks/>
              <a:stCxn id="61" idx="3"/>
            </p:cNvCxnSpPr>
            <p:nvPr/>
          </p:nvCxnSpPr>
          <p:spPr>
            <a:xfrm>
              <a:off x="6443635" y="1549791"/>
              <a:ext cx="376006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81719E6-6987-5A31-F86A-FEB06F642DAA}"/>
                </a:ext>
              </a:extLst>
            </p:cNvPr>
            <p:cNvSpPr txBox="1"/>
            <p:nvPr/>
          </p:nvSpPr>
          <p:spPr>
            <a:xfrm>
              <a:off x="1964599" y="806307"/>
              <a:ext cx="1316519" cy="575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74" b="1" i="1" dirty="0"/>
                <a:t>Allocation of mice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F89906B-B4BF-6F8B-1BE8-505C03F1CBE7}"/>
                </a:ext>
              </a:extLst>
            </p:cNvPr>
            <p:cNvSpPr txBox="1"/>
            <p:nvPr/>
          </p:nvSpPr>
          <p:spPr>
            <a:xfrm>
              <a:off x="4005224" y="735116"/>
              <a:ext cx="780022" cy="3345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74" b="1" i="1" dirty="0"/>
                <a:t>Groups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7C5ABB5-87E9-6A44-B6A8-D1A2E6AD9EA9}"/>
                </a:ext>
              </a:extLst>
            </p:cNvPr>
            <p:cNvSpPr txBox="1"/>
            <p:nvPr/>
          </p:nvSpPr>
          <p:spPr>
            <a:xfrm>
              <a:off x="4998358" y="727197"/>
              <a:ext cx="1878852" cy="575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74" b="1" i="1" dirty="0"/>
                <a:t>Pharmacological intervention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04D52768-D36E-BFF4-1833-0959DE2C21D4}"/>
                </a:ext>
              </a:extLst>
            </p:cNvPr>
            <p:cNvSpPr txBox="1"/>
            <p:nvPr/>
          </p:nvSpPr>
          <p:spPr>
            <a:xfrm>
              <a:off x="6819641" y="1030372"/>
              <a:ext cx="2347135" cy="17565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AD-related gene expression (</a:t>
              </a:r>
              <a:r>
                <a:rPr lang="en-US" sz="984" i="1" dirty="0"/>
                <a:t>PSEN1</a:t>
              </a:r>
              <a:r>
                <a:rPr lang="en-US" sz="984" dirty="0"/>
                <a:t>, </a:t>
              </a:r>
              <a:r>
                <a:rPr lang="en-US" sz="984" i="1" dirty="0"/>
                <a:t>PSEN2</a:t>
              </a:r>
              <a:r>
                <a:rPr lang="en-US" sz="984" dirty="0"/>
                <a:t>, </a:t>
              </a:r>
              <a:r>
                <a:rPr lang="en-US" sz="984" i="1" dirty="0"/>
                <a:t>APOE</a:t>
              </a:r>
              <a:r>
                <a:rPr lang="en-US" sz="984" dirty="0"/>
                <a:t>, </a:t>
              </a:r>
              <a:r>
                <a:rPr lang="en-US" sz="984" i="1" dirty="0"/>
                <a:t>MAPT</a:t>
              </a:r>
              <a:r>
                <a:rPr lang="en-US" sz="984" dirty="0"/>
                <a:t>, </a:t>
              </a:r>
              <a:r>
                <a:rPr lang="en-US" sz="984" i="1" dirty="0"/>
                <a:t>ABCB7</a:t>
              </a:r>
              <a:r>
                <a:rPr lang="en-US" sz="984" dirty="0"/>
                <a:t>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Inflammation-related gene expression (</a:t>
              </a:r>
              <a:r>
                <a:rPr lang="en-US" sz="984" i="1" dirty="0"/>
                <a:t>IL-1</a:t>
              </a:r>
              <a:r>
                <a:rPr lang="el-GR" sz="984" i="1" dirty="0">
                  <a:latin typeface="Palatino Linotype" panose="02040502050505030304" pitchFamily="18" charset="0"/>
                  <a:cs typeface="Calibri" panose="020F0502020204030204" pitchFamily="34" charset="0"/>
                </a:rPr>
                <a:t>β</a:t>
              </a:r>
              <a:r>
                <a:rPr lang="en-US" sz="984" dirty="0"/>
                <a:t>, </a:t>
              </a:r>
              <a:r>
                <a:rPr lang="en-US" sz="984" i="1" dirty="0"/>
                <a:t>IL-6</a:t>
              </a:r>
              <a:r>
                <a:rPr lang="en-US" sz="984" dirty="0"/>
                <a:t>, </a:t>
              </a:r>
              <a:r>
                <a:rPr lang="en-US" sz="984" i="1" dirty="0"/>
                <a:t>TNF</a:t>
              </a:r>
              <a:r>
                <a:rPr lang="el-GR" sz="984" i="1" dirty="0">
                  <a:latin typeface="Palatino Linotype" panose="02040502050505030304" pitchFamily="18" charset="0"/>
                  <a:cs typeface="Calibri" panose="020F0502020204030204" pitchFamily="34" charset="0"/>
                </a:rPr>
                <a:t>α</a:t>
              </a:r>
              <a:r>
                <a:rPr lang="en-US" sz="984" dirty="0"/>
                <a:t>, </a:t>
              </a:r>
              <a:r>
                <a:rPr lang="en-US" sz="984" i="1" dirty="0"/>
                <a:t>NOS3</a:t>
              </a:r>
              <a:r>
                <a:rPr lang="en-US" sz="984" dirty="0"/>
                <a:t>, </a:t>
              </a:r>
              <a:r>
                <a:rPr lang="en-US" sz="984" i="1" dirty="0"/>
                <a:t>COX-2</a:t>
              </a:r>
              <a:r>
                <a:rPr lang="en-US" sz="984" dirty="0"/>
                <a:t>) 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DNA methylation (5mC, </a:t>
              </a:r>
              <a:r>
                <a:rPr lang="en-US" sz="984" i="1" dirty="0"/>
                <a:t>DNMT1</a:t>
              </a:r>
              <a:r>
                <a:rPr lang="en-US" sz="984" dirty="0"/>
                <a:t>, </a:t>
              </a:r>
              <a:r>
                <a:rPr lang="en-US" sz="984" i="1" dirty="0"/>
                <a:t>DNMT3a</a:t>
              </a:r>
              <a:r>
                <a:rPr lang="en-US" sz="984" dirty="0"/>
                <a:t>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Chromatin remodeling (SIRT activity, </a:t>
              </a:r>
              <a:r>
                <a:rPr lang="en-US" sz="984" i="1" dirty="0"/>
                <a:t>SIRT1</a:t>
              </a:r>
              <a:r>
                <a:rPr lang="en-US" sz="984" dirty="0"/>
                <a:t>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Histone modifications (HDAC activity, </a:t>
              </a:r>
              <a:r>
                <a:rPr lang="en-US" sz="984" i="1" dirty="0"/>
                <a:t>HDAC3</a:t>
              </a:r>
              <a:r>
                <a:rPr lang="en-US" sz="984" dirty="0"/>
                <a:t>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 err="1"/>
                <a:t>NeuN</a:t>
              </a:r>
              <a:r>
                <a:rPr lang="en-US" sz="984" dirty="0"/>
                <a:t> and TH immunostaining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E96B4CE-C3FF-E591-4138-F21DF7987FA2}"/>
                </a:ext>
              </a:extLst>
            </p:cNvPr>
            <p:cNvSpPr txBox="1"/>
            <p:nvPr/>
          </p:nvSpPr>
          <p:spPr>
            <a:xfrm>
              <a:off x="7070599" y="742134"/>
              <a:ext cx="1878852" cy="3331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74" b="1" i="1" dirty="0"/>
                <a:t>Measurements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85C0106-323F-1B97-49F8-47FF427F440E}"/>
                </a:ext>
              </a:extLst>
            </p:cNvPr>
            <p:cNvSpPr txBox="1"/>
            <p:nvPr/>
          </p:nvSpPr>
          <p:spPr>
            <a:xfrm>
              <a:off x="7070599" y="3005724"/>
              <a:ext cx="1878852" cy="363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1" i="1" dirty="0"/>
                <a:t>Analysis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37467D3-0E21-7641-5E10-45071984F768}"/>
                </a:ext>
              </a:extLst>
            </p:cNvPr>
            <p:cNvSpPr txBox="1"/>
            <p:nvPr/>
          </p:nvSpPr>
          <p:spPr>
            <a:xfrm>
              <a:off x="6819641" y="3338148"/>
              <a:ext cx="2192592" cy="5451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Shapiro-Wilk test (normality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 err="1"/>
                <a:t>Levene’s</a:t>
              </a:r>
              <a:r>
                <a:rPr lang="en-US" sz="984" dirty="0"/>
                <a:t> test (equality of variances)</a:t>
              </a:r>
            </a:p>
            <a:p>
              <a:pPr marL="168707" indent="-168707">
                <a:buFont typeface="Arial" panose="020B0604020202020204" pitchFamily="34" charset="0"/>
                <a:buChar char="•"/>
              </a:pPr>
              <a:r>
                <a:rPr lang="en-US" sz="984" dirty="0"/>
                <a:t>Unpaired </a:t>
              </a:r>
              <a:r>
                <a:rPr lang="en-US" sz="984" i="1" dirty="0"/>
                <a:t>t</a:t>
              </a:r>
              <a:r>
                <a:rPr lang="en-US" sz="984" dirty="0"/>
                <a:t>-test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EB0E8640-D588-2BDD-B056-249CC3EDE2B7}"/>
                </a:ext>
              </a:extLst>
            </p:cNvPr>
            <p:cNvSpPr txBox="1"/>
            <p:nvPr/>
          </p:nvSpPr>
          <p:spPr>
            <a:xfrm>
              <a:off x="5452260" y="3425695"/>
              <a:ext cx="1222747" cy="242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84" dirty="0"/>
                <a:t>is blocking factor for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0D0CE889-2EC2-0FBD-360C-A2DD01F8E541}"/>
                </a:ext>
              </a:extLst>
            </p:cNvPr>
            <p:cNvSpPr txBox="1"/>
            <p:nvPr/>
          </p:nvSpPr>
          <p:spPr>
            <a:xfrm>
              <a:off x="3354095" y="3402500"/>
              <a:ext cx="1222747" cy="242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84" dirty="0"/>
                <a:t>is blocking factor for</a:t>
              </a:r>
            </a:p>
          </p:txBody>
        </p:sp>
        <p:cxnSp>
          <p:nvCxnSpPr>
            <p:cNvPr id="163" name="Straight Arrow Connector 162">
              <a:extLst>
                <a:ext uri="{FF2B5EF4-FFF2-40B4-BE49-F238E27FC236}">
                  <a16:creationId xmlns:a16="http://schemas.microsoft.com/office/drawing/2014/main" id="{8FD451DF-B74F-20DB-EA5F-15501318BC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96778" y="1566895"/>
              <a:ext cx="575706" cy="1629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Arrow Connector 163">
              <a:extLst>
                <a:ext uri="{FF2B5EF4-FFF2-40B4-BE49-F238E27FC236}">
                  <a16:creationId xmlns:a16="http://schemas.microsoft.com/office/drawing/2014/main" id="{C320EA77-9ED5-5659-1B61-43AEB3195C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98231" y="1716854"/>
              <a:ext cx="575706" cy="1629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Arrow Connector 170">
              <a:extLst>
                <a:ext uri="{FF2B5EF4-FFF2-40B4-BE49-F238E27FC236}">
                  <a16:creationId xmlns:a16="http://schemas.microsoft.com/office/drawing/2014/main" id="{502D6A88-B790-021C-07F1-53BD69FD819E}"/>
                </a:ext>
              </a:extLst>
            </p:cNvPr>
            <p:cNvCxnSpPr>
              <a:stCxn id="10" idx="3"/>
            </p:cNvCxnSpPr>
            <p:nvPr/>
          </p:nvCxnSpPr>
          <p:spPr>
            <a:xfrm>
              <a:off x="5008281" y="1204530"/>
              <a:ext cx="331249" cy="10909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Arrow Connector 172">
              <a:extLst>
                <a:ext uri="{FF2B5EF4-FFF2-40B4-BE49-F238E27FC236}">
                  <a16:creationId xmlns:a16="http://schemas.microsoft.com/office/drawing/2014/main" id="{D6986984-80C7-767D-8B55-C17B8F8F4DC2}"/>
                </a:ext>
              </a:extLst>
            </p:cNvPr>
            <p:cNvCxnSpPr>
              <a:cxnSpLocks/>
              <a:stCxn id="16" idx="3"/>
              <a:endCxn id="61" idx="1"/>
            </p:cNvCxnSpPr>
            <p:nvPr/>
          </p:nvCxnSpPr>
          <p:spPr>
            <a:xfrm flipV="1">
              <a:off x="5008282" y="1549791"/>
              <a:ext cx="331248" cy="95727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Arrow Connector 174">
              <a:extLst>
                <a:ext uri="{FF2B5EF4-FFF2-40B4-BE49-F238E27FC236}">
                  <a16:creationId xmlns:a16="http://schemas.microsoft.com/office/drawing/2014/main" id="{2B6591C6-637F-BDCD-CDDD-E3FDF19E34D2}"/>
                </a:ext>
              </a:extLst>
            </p:cNvPr>
            <p:cNvCxnSpPr>
              <a:stCxn id="17" idx="3"/>
            </p:cNvCxnSpPr>
            <p:nvPr/>
          </p:nvCxnSpPr>
          <p:spPr>
            <a:xfrm>
              <a:off x="5008281" y="2062280"/>
              <a:ext cx="322130" cy="2365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Straight Arrow Connector 176">
              <a:extLst>
                <a:ext uri="{FF2B5EF4-FFF2-40B4-BE49-F238E27FC236}">
                  <a16:creationId xmlns:a16="http://schemas.microsoft.com/office/drawing/2014/main" id="{2283F0CE-A60C-B323-C74A-618DCD28548C}"/>
                </a:ext>
              </a:extLst>
            </p:cNvPr>
            <p:cNvCxnSpPr>
              <a:cxnSpLocks/>
              <a:stCxn id="11" idx="3"/>
            </p:cNvCxnSpPr>
            <p:nvPr/>
          </p:nvCxnSpPr>
          <p:spPr>
            <a:xfrm flipV="1">
              <a:off x="5008281" y="2354814"/>
              <a:ext cx="321805" cy="13680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Straight Arrow Connector 204">
              <a:extLst>
                <a:ext uri="{FF2B5EF4-FFF2-40B4-BE49-F238E27FC236}">
                  <a16:creationId xmlns:a16="http://schemas.microsoft.com/office/drawing/2014/main" id="{4904440D-86A2-4DA4-1E26-8C7A68C861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39311" y="3746611"/>
              <a:ext cx="94633" cy="14843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Straight Arrow Connector 215">
              <a:extLst>
                <a:ext uri="{FF2B5EF4-FFF2-40B4-BE49-F238E27FC236}">
                  <a16:creationId xmlns:a16="http://schemas.microsoft.com/office/drawing/2014/main" id="{092D2D1E-CBB6-0A3F-8C8C-F3D6C344F601}"/>
                </a:ext>
              </a:extLst>
            </p:cNvPr>
            <p:cNvCxnSpPr>
              <a:cxnSpLocks/>
            </p:cNvCxnSpPr>
            <p:nvPr/>
          </p:nvCxnSpPr>
          <p:spPr>
            <a:xfrm>
              <a:off x="5334370" y="3744954"/>
              <a:ext cx="85248" cy="146941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Straight Arrow Connector 224">
              <a:extLst>
                <a:ext uri="{FF2B5EF4-FFF2-40B4-BE49-F238E27FC236}">
                  <a16:creationId xmlns:a16="http://schemas.microsoft.com/office/drawing/2014/main" id="{83EDFE06-B10F-72F1-130E-F9A8DFB5C3C1}"/>
                </a:ext>
              </a:extLst>
            </p:cNvPr>
            <p:cNvCxnSpPr>
              <a:cxnSpLocks/>
            </p:cNvCxnSpPr>
            <p:nvPr/>
          </p:nvCxnSpPr>
          <p:spPr>
            <a:xfrm>
              <a:off x="6441324" y="2237977"/>
              <a:ext cx="380665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Arrow Connector 247">
              <a:extLst>
                <a:ext uri="{FF2B5EF4-FFF2-40B4-BE49-F238E27FC236}">
                  <a16:creationId xmlns:a16="http://schemas.microsoft.com/office/drawing/2014/main" id="{3CAAC823-25F2-0D1D-FF43-38C8D5429DC8}"/>
                </a:ext>
              </a:extLst>
            </p:cNvPr>
            <p:cNvCxnSpPr/>
            <p:nvPr/>
          </p:nvCxnSpPr>
          <p:spPr>
            <a:xfrm flipH="1">
              <a:off x="8025239" y="2786887"/>
              <a:ext cx="2688" cy="28656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Arrow Connector 197">
              <a:extLst>
                <a:ext uri="{FF2B5EF4-FFF2-40B4-BE49-F238E27FC236}">
                  <a16:creationId xmlns:a16="http://schemas.microsoft.com/office/drawing/2014/main" id="{73F43ED7-D8F7-042A-7C3E-AE064FE391A3}"/>
                </a:ext>
              </a:extLst>
            </p:cNvPr>
            <p:cNvCxnSpPr>
              <a:cxnSpLocks/>
              <a:endCxn id="18" idx="2"/>
            </p:cNvCxnSpPr>
            <p:nvPr/>
          </p:nvCxnSpPr>
          <p:spPr>
            <a:xfrm flipV="1">
              <a:off x="2633976" y="1888945"/>
              <a:ext cx="0" cy="1710345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Straight Connector 254">
              <a:extLst>
                <a:ext uri="{FF2B5EF4-FFF2-40B4-BE49-F238E27FC236}">
                  <a16:creationId xmlns:a16="http://schemas.microsoft.com/office/drawing/2014/main" id="{6D4D577C-FA52-E97D-54DB-4C730BC75B99}"/>
                </a:ext>
              </a:extLst>
            </p:cNvPr>
            <p:cNvCxnSpPr>
              <a:cxnSpLocks/>
              <a:stCxn id="19" idx="1"/>
            </p:cNvCxnSpPr>
            <p:nvPr/>
          </p:nvCxnSpPr>
          <p:spPr>
            <a:xfrm flipH="1" flipV="1">
              <a:off x="2629866" y="3603509"/>
              <a:ext cx="2305560" cy="3520"/>
            </a:xfrm>
            <a:prstGeom prst="line">
              <a:avLst/>
            </a:prstGeom>
            <a:ln w="12700"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Straight Arrow Connector 260">
              <a:extLst>
                <a:ext uri="{FF2B5EF4-FFF2-40B4-BE49-F238E27FC236}">
                  <a16:creationId xmlns:a16="http://schemas.microsoft.com/office/drawing/2014/main" id="{C3F4DF9E-147D-EA1C-3453-79E3F2CB2010}"/>
                </a:ext>
              </a:extLst>
            </p:cNvPr>
            <p:cNvCxnSpPr>
              <a:cxnSpLocks/>
              <a:stCxn id="19" idx="3"/>
              <a:endCxn id="101" idx="1"/>
            </p:cNvCxnSpPr>
            <p:nvPr/>
          </p:nvCxnSpPr>
          <p:spPr>
            <a:xfrm>
              <a:off x="5330086" y="3607029"/>
              <a:ext cx="1489555" cy="368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0867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15</Words>
  <Application>Microsoft Office PowerPoint</Application>
  <PresentationFormat>Widescreen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N</dc:creator>
  <cp:lastModifiedBy>MDPI</cp:lastModifiedBy>
  <cp:revision>8</cp:revision>
  <dcterms:created xsi:type="dcterms:W3CDTF">2022-08-29T11:34:19Z</dcterms:created>
  <dcterms:modified xsi:type="dcterms:W3CDTF">2022-11-12T05:20:02Z</dcterms:modified>
</cp:coreProperties>
</file>